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7578725" cy="9144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1DF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82601" autoAdjust="0"/>
  </p:normalViewPr>
  <p:slideViewPr>
    <p:cSldViewPr snapToGrid="0">
      <p:cViewPr>
        <p:scale>
          <a:sx n="75" d="100"/>
          <a:sy n="75" d="100"/>
        </p:scale>
        <p:origin x="1626" y="-8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B6486D-198B-44C0-9C62-7167CB6C8C51}" type="datetimeFigureOut">
              <a:rPr lang="zh-CN" altLang="en-US" smtClean="0"/>
              <a:t>2022/7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51063" y="1143000"/>
            <a:ext cx="25558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A931C3-5648-49E7-9CDF-5A81F0E025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03536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51063" y="1143000"/>
            <a:ext cx="25558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1 Flow chart of study cohort selection.</a:t>
            </a:r>
          </a:p>
          <a:p>
            <a:r>
              <a:rPr lang="en-US" altLang="zh-CN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Abbreviations: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CNP, low cranial nerve palsy; NPC, nasopharyngeal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cinoma; SYSMH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the Sun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at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Sen Memorial hospital; FPHF, the First People's Hospital of Foshan  </a:t>
            </a:r>
            <a:endParaRPr lang="zh-CN" altLang="en-US" sz="1200" dirty="0" smtClean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A931C3-5648-49E7-9CDF-5A81F0E0257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79832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8405" y="1496484"/>
            <a:ext cx="6441916" cy="3183467"/>
          </a:xfrm>
        </p:spPr>
        <p:txBody>
          <a:bodyPr anchor="b"/>
          <a:lstStyle>
            <a:lvl1pPr algn="ctr">
              <a:defRPr sz="497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7341" y="4802717"/>
            <a:ext cx="5684044" cy="2207683"/>
          </a:xfrm>
        </p:spPr>
        <p:txBody>
          <a:bodyPr/>
          <a:lstStyle>
            <a:lvl1pPr marL="0" indent="0" algn="ctr">
              <a:buNone/>
              <a:defRPr sz="1989"/>
            </a:lvl1pPr>
            <a:lvl2pPr marL="378927" indent="0" algn="ctr">
              <a:buNone/>
              <a:defRPr sz="1658"/>
            </a:lvl2pPr>
            <a:lvl3pPr marL="757855" indent="0" algn="ctr">
              <a:buNone/>
              <a:defRPr sz="1492"/>
            </a:lvl3pPr>
            <a:lvl4pPr marL="1136782" indent="0" algn="ctr">
              <a:buNone/>
              <a:defRPr sz="1326"/>
            </a:lvl4pPr>
            <a:lvl5pPr marL="1515709" indent="0" algn="ctr">
              <a:buNone/>
              <a:defRPr sz="1326"/>
            </a:lvl5pPr>
            <a:lvl6pPr marL="1894637" indent="0" algn="ctr">
              <a:buNone/>
              <a:defRPr sz="1326"/>
            </a:lvl6pPr>
            <a:lvl7pPr marL="2273564" indent="0" algn="ctr">
              <a:buNone/>
              <a:defRPr sz="1326"/>
            </a:lvl7pPr>
            <a:lvl8pPr marL="2652492" indent="0" algn="ctr">
              <a:buNone/>
              <a:defRPr sz="1326"/>
            </a:lvl8pPr>
            <a:lvl9pPr marL="3031419" indent="0" algn="ctr">
              <a:buNone/>
              <a:defRPr sz="1326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584A-C1CC-4B36-9EEC-2EFD01E4524D}" type="datetimeFigureOut">
              <a:rPr lang="zh-CN" altLang="en-US" smtClean="0"/>
              <a:t>2022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F4592-4119-416C-B5F3-355B1753D5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3124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584A-C1CC-4B36-9EEC-2EFD01E4524D}" type="datetimeFigureOut">
              <a:rPr lang="zh-CN" altLang="en-US" smtClean="0"/>
              <a:t>2022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F4592-4119-416C-B5F3-355B1753D5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8948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23525" y="486834"/>
            <a:ext cx="1634163" cy="77491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1038" y="486834"/>
            <a:ext cx="4807754" cy="77491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584A-C1CC-4B36-9EEC-2EFD01E4524D}" type="datetimeFigureOut">
              <a:rPr lang="zh-CN" altLang="en-US" smtClean="0"/>
              <a:t>2022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F4592-4119-416C-B5F3-355B1753D5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5501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584A-C1CC-4B36-9EEC-2EFD01E4524D}" type="datetimeFigureOut">
              <a:rPr lang="zh-CN" altLang="en-US" smtClean="0"/>
              <a:t>2022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F4592-4119-416C-B5F3-355B1753D5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0642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091" y="2279653"/>
            <a:ext cx="6536650" cy="3803649"/>
          </a:xfrm>
        </p:spPr>
        <p:txBody>
          <a:bodyPr anchor="b"/>
          <a:lstStyle>
            <a:lvl1pPr>
              <a:defRPr sz="497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091" y="6119286"/>
            <a:ext cx="6536650" cy="2000249"/>
          </a:xfrm>
        </p:spPr>
        <p:txBody>
          <a:bodyPr/>
          <a:lstStyle>
            <a:lvl1pPr marL="0" indent="0">
              <a:buNone/>
              <a:defRPr sz="1989">
                <a:solidFill>
                  <a:schemeClr val="tx1"/>
                </a:solidFill>
              </a:defRPr>
            </a:lvl1pPr>
            <a:lvl2pPr marL="378927" indent="0">
              <a:buNone/>
              <a:defRPr sz="1658">
                <a:solidFill>
                  <a:schemeClr val="tx1">
                    <a:tint val="75000"/>
                  </a:schemeClr>
                </a:solidFill>
              </a:defRPr>
            </a:lvl2pPr>
            <a:lvl3pPr marL="757855" indent="0">
              <a:buNone/>
              <a:defRPr sz="1492">
                <a:solidFill>
                  <a:schemeClr val="tx1">
                    <a:tint val="75000"/>
                  </a:schemeClr>
                </a:solidFill>
              </a:defRPr>
            </a:lvl3pPr>
            <a:lvl4pPr marL="1136782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4pPr>
            <a:lvl5pPr marL="1515709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5pPr>
            <a:lvl6pPr marL="1894637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6pPr>
            <a:lvl7pPr marL="2273564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7pPr>
            <a:lvl8pPr marL="2652492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8pPr>
            <a:lvl9pPr marL="3031419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584A-C1CC-4B36-9EEC-2EFD01E4524D}" type="datetimeFigureOut">
              <a:rPr lang="zh-CN" altLang="en-US" smtClean="0"/>
              <a:t>2022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F4592-4119-416C-B5F3-355B1753D5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2382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1037" y="2434167"/>
            <a:ext cx="3220958" cy="580178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36730" y="2434167"/>
            <a:ext cx="3220958" cy="580178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584A-C1CC-4B36-9EEC-2EFD01E4524D}" type="datetimeFigureOut">
              <a:rPr lang="zh-CN" altLang="en-US" smtClean="0"/>
              <a:t>2022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F4592-4119-416C-B5F3-355B1753D5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6384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025" y="486836"/>
            <a:ext cx="6536650" cy="1767417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2026" y="2241551"/>
            <a:ext cx="3206155" cy="1098549"/>
          </a:xfrm>
        </p:spPr>
        <p:txBody>
          <a:bodyPr anchor="b"/>
          <a:lstStyle>
            <a:lvl1pPr marL="0" indent="0">
              <a:buNone/>
              <a:defRPr sz="1989" b="1"/>
            </a:lvl1pPr>
            <a:lvl2pPr marL="378927" indent="0">
              <a:buNone/>
              <a:defRPr sz="1658" b="1"/>
            </a:lvl2pPr>
            <a:lvl3pPr marL="757855" indent="0">
              <a:buNone/>
              <a:defRPr sz="1492" b="1"/>
            </a:lvl3pPr>
            <a:lvl4pPr marL="1136782" indent="0">
              <a:buNone/>
              <a:defRPr sz="1326" b="1"/>
            </a:lvl4pPr>
            <a:lvl5pPr marL="1515709" indent="0">
              <a:buNone/>
              <a:defRPr sz="1326" b="1"/>
            </a:lvl5pPr>
            <a:lvl6pPr marL="1894637" indent="0">
              <a:buNone/>
              <a:defRPr sz="1326" b="1"/>
            </a:lvl6pPr>
            <a:lvl7pPr marL="2273564" indent="0">
              <a:buNone/>
              <a:defRPr sz="1326" b="1"/>
            </a:lvl7pPr>
            <a:lvl8pPr marL="2652492" indent="0">
              <a:buNone/>
              <a:defRPr sz="1326" b="1"/>
            </a:lvl8pPr>
            <a:lvl9pPr marL="3031419" indent="0">
              <a:buNone/>
              <a:defRPr sz="1326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2026" y="3340100"/>
            <a:ext cx="3206155" cy="491278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36730" y="2241551"/>
            <a:ext cx="3221945" cy="1098549"/>
          </a:xfrm>
        </p:spPr>
        <p:txBody>
          <a:bodyPr anchor="b"/>
          <a:lstStyle>
            <a:lvl1pPr marL="0" indent="0">
              <a:buNone/>
              <a:defRPr sz="1989" b="1"/>
            </a:lvl1pPr>
            <a:lvl2pPr marL="378927" indent="0">
              <a:buNone/>
              <a:defRPr sz="1658" b="1"/>
            </a:lvl2pPr>
            <a:lvl3pPr marL="757855" indent="0">
              <a:buNone/>
              <a:defRPr sz="1492" b="1"/>
            </a:lvl3pPr>
            <a:lvl4pPr marL="1136782" indent="0">
              <a:buNone/>
              <a:defRPr sz="1326" b="1"/>
            </a:lvl4pPr>
            <a:lvl5pPr marL="1515709" indent="0">
              <a:buNone/>
              <a:defRPr sz="1326" b="1"/>
            </a:lvl5pPr>
            <a:lvl6pPr marL="1894637" indent="0">
              <a:buNone/>
              <a:defRPr sz="1326" b="1"/>
            </a:lvl6pPr>
            <a:lvl7pPr marL="2273564" indent="0">
              <a:buNone/>
              <a:defRPr sz="1326" b="1"/>
            </a:lvl7pPr>
            <a:lvl8pPr marL="2652492" indent="0">
              <a:buNone/>
              <a:defRPr sz="1326" b="1"/>
            </a:lvl8pPr>
            <a:lvl9pPr marL="3031419" indent="0">
              <a:buNone/>
              <a:defRPr sz="1326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36730" y="3340100"/>
            <a:ext cx="3221945" cy="491278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584A-C1CC-4B36-9EEC-2EFD01E4524D}" type="datetimeFigureOut">
              <a:rPr lang="zh-CN" altLang="en-US" smtClean="0"/>
              <a:t>2022/7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F4592-4119-416C-B5F3-355B1753D5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4228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584A-C1CC-4B36-9EEC-2EFD01E4524D}" type="datetimeFigureOut">
              <a:rPr lang="zh-CN" altLang="en-US" smtClean="0"/>
              <a:t>2022/7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F4592-4119-416C-B5F3-355B1753D5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9759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584A-C1CC-4B36-9EEC-2EFD01E4524D}" type="datetimeFigureOut">
              <a:rPr lang="zh-CN" altLang="en-US" smtClean="0"/>
              <a:t>2022/7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F4592-4119-416C-B5F3-355B1753D5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4342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025" y="609600"/>
            <a:ext cx="2444336" cy="2133600"/>
          </a:xfrm>
        </p:spPr>
        <p:txBody>
          <a:bodyPr anchor="b"/>
          <a:lstStyle>
            <a:lvl1pPr>
              <a:defRPr sz="2652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21945" y="1316569"/>
            <a:ext cx="3836730" cy="6498167"/>
          </a:xfrm>
        </p:spPr>
        <p:txBody>
          <a:bodyPr/>
          <a:lstStyle>
            <a:lvl1pPr>
              <a:defRPr sz="2652"/>
            </a:lvl1pPr>
            <a:lvl2pPr>
              <a:defRPr sz="2321"/>
            </a:lvl2pPr>
            <a:lvl3pPr>
              <a:defRPr sz="1989"/>
            </a:lvl3pPr>
            <a:lvl4pPr>
              <a:defRPr sz="1658"/>
            </a:lvl4pPr>
            <a:lvl5pPr>
              <a:defRPr sz="1658"/>
            </a:lvl5pPr>
            <a:lvl6pPr>
              <a:defRPr sz="1658"/>
            </a:lvl6pPr>
            <a:lvl7pPr>
              <a:defRPr sz="1658"/>
            </a:lvl7pPr>
            <a:lvl8pPr>
              <a:defRPr sz="1658"/>
            </a:lvl8pPr>
            <a:lvl9pPr>
              <a:defRPr sz="1658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025" y="2743200"/>
            <a:ext cx="2444336" cy="5082117"/>
          </a:xfrm>
        </p:spPr>
        <p:txBody>
          <a:bodyPr/>
          <a:lstStyle>
            <a:lvl1pPr marL="0" indent="0">
              <a:buNone/>
              <a:defRPr sz="1326"/>
            </a:lvl1pPr>
            <a:lvl2pPr marL="378927" indent="0">
              <a:buNone/>
              <a:defRPr sz="1160"/>
            </a:lvl2pPr>
            <a:lvl3pPr marL="757855" indent="0">
              <a:buNone/>
              <a:defRPr sz="995"/>
            </a:lvl3pPr>
            <a:lvl4pPr marL="1136782" indent="0">
              <a:buNone/>
              <a:defRPr sz="829"/>
            </a:lvl4pPr>
            <a:lvl5pPr marL="1515709" indent="0">
              <a:buNone/>
              <a:defRPr sz="829"/>
            </a:lvl5pPr>
            <a:lvl6pPr marL="1894637" indent="0">
              <a:buNone/>
              <a:defRPr sz="829"/>
            </a:lvl6pPr>
            <a:lvl7pPr marL="2273564" indent="0">
              <a:buNone/>
              <a:defRPr sz="829"/>
            </a:lvl7pPr>
            <a:lvl8pPr marL="2652492" indent="0">
              <a:buNone/>
              <a:defRPr sz="829"/>
            </a:lvl8pPr>
            <a:lvl9pPr marL="3031419" indent="0">
              <a:buNone/>
              <a:defRPr sz="829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584A-C1CC-4B36-9EEC-2EFD01E4524D}" type="datetimeFigureOut">
              <a:rPr lang="zh-CN" altLang="en-US" smtClean="0"/>
              <a:t>2022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F4592-4119-416C-B5F3-355B1753D5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9689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025" y="609600"/>
            <a:ext cx="2444336" cy="2133600"/>
          </a:xfrm>
        </p:spPr>
        <p:txBody>
          <a:bodyPr anchor="b"/>
          <a:lstStyle>
            <a:lvl1pPr>
              <a:defRPr sz="2652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21945" y="1316569"/>
            <a:ext cx="3836730" cy="6498167"/>
          </a:xfrm>
        </p:spPr>
        <p:txBody>
          <a:bodyPr anchor="t"/>
          <a:lstStyle>
            <a:lvl1pPr marL="0" indent="0">
              <a:buNone/>
              <a:defRPr sz="2652"/>
            </a:lvl1pPr>
            <a:lvl2pPr marL="378927" indent="0">
              <a:buNone/>
              <a:defRPr sz="2321"/>
            </a:lvl2pPr>
            <a:lvl3pPr marL="757855" indent="0">
              <a:buNone/>
              <a:defRPr sz="1989"/>
            </a:lvl3pPr>
            <a:lvl4pPr marL="1136782" indent="0">
              <a:buNone/>
              <a:defRPr sz="1658"/>
            </a:lvl4pPr>
            <a:lvl5pPr marL="1515709" indent="0">
              <a:buNone/>
              <a:defRPr sz="1658"/>
            </a:lvl5pPr>
            <a:lvl6pPr marL="1894637" indent="0">
              <a:buNone/>
              <a:defRPr sz="1658"/>
            </a:lvl6pPr>
            <a:lvl7pPr marL="2273564" indent="0">
              <a:buNone/>
              <a:defRPr sz="1658"/>
            </a:lvl7pPr>
            <a:lvl8pPr marL="2652492" indent="0">
              <a:buNone/>
              <a:defRPr sz="1658"/>
            </a:lvl8pPr>
            <a:lvl9pPr marL="3031419" indent="0">
              <a:buNone/>
              <a:defRPr sz="1658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025" y="2743200"/>
            <a:ext cx="2444336" cy="5082117"/>
          </a:xfrm>
        </p:spPr>
        <p:txBody>
          <a:bodyPr/>
          <a:lstStyle>
            <a:lvl1pPr marL="0" indent="0">
              <a:buNone/>
              <a:defRPr sz="1326"/>
            </a:lvl1pPr>
            <a:lvl2pPr marL="378927" indent="0">
              <a:buNone/>
              <a:defRPr sz="1160"/>
            </a:lvl2pPr>
            <a:lvl3pPr marL="757855" indent="0">
              <a:buNone/>
              <a:defRPr sz="995"/>
            </a:lvl3pPr>
            <a:lvl4pPr marL="1136782" indent="0">
              <a:buNone/>
              <a:defRPr sz="829"/>
            </a:lvl4pPr>
            <a:lvl5pPr marL="1515709" indent="0">
              <a:buNone/>
              <a:defRPr sz="829"/>
            </a:lvl5pPr>
            <a:lvl6pPr marL="1894637" indent="0">
              <a:buNone/>
              <a:defRPr sz="829"/>
            </a:lvl6pPr>
            <a:lvl7pPr marL="2273564" indent="0">
              <a:buNone/>
              <a:defRPr sz="829"/>
            </a:lvl7pPr>
            <a:lvl8pPr marL="2652492" indent="0">
              <a:buNone/>
              <a:defRPr sz="829"/>
            </a:lvl8pPr>
            <a:lvl9pPr marL="3031419" indent="0">
              <a:buNone/>
              <a:defRPr sz="829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8584A-C1CC-4B36-9EEC-2EFD01E4524D}" type="datetimeFigureOut">
              <a:rPr lang="zh-CN" altLang="en-US" smtClean="0"/>
              <a:t>2022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F4592-4119-416C-B5F3-355B1753D5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5565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1038" y="486836"/>
            <a:ext cx="653665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1038" y="2434167"/>
            <a:ext cx="653665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1037" y="8475136"/>
            <a:ext cx="1705213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88584A-C1CC-4B36-9EEC-2EFD01E4524D}" type="datetimeFigureOut">
              <a:rPr lang="zh-CN" altLang="en-US" smtClean="0"/>
              <a:t>2022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10453" y="8475136"/>
            <a:ext cx="25578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52475" y="8475136"/>
            <a:ext cx="1705213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2F4592-4119-416C-B5F3-355B1753D5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4995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7855" rtl="0" eaLnBrk="1" latinLnBrk="0" hangingPunct="1">
        <a:lnSpc>
          <a:spcPct val="90000"/>
        </a:lnSpc>
        <a:spcBef>
          <a:spcPct val="0"/>
        </a:spcBef>
        <a:buNone/>
        <a:defRPr sz="36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464" indent="-189464" algn="l" defTabSz="757855" rtl="0" eaLnBrk="1" latinLnBrk="0" hangingPunct="1">
        <a:lnSpc>
          <a:spcPct val="90000"/>
        </a:lnSpc>
        <a:spcBef>
          <a:spcPts val="829"/>
        </a:spcBef>
        <a:buFont typeface="Arial" panose="020B0604020202020204" pitchFamily="34" charset="0"/>
        <a:buChar char="•"/>
        <a:defRPr sz="2321" kern="1200">
          <a:solidFill>
            <a:schemeClr val="tx1"/>
          </a:solidFill>
          <a:latin typeface="+mn-lt"/>
          <a:ea typeface="+mn-ea"/>
          <a:cs typeface="+mn-cs"/>
        </a:defRPr>
      </a:lvl1pPr>
      <a:lvl2pPr marL="568391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989" kern="1200">
          <a:solidFill>
            <a:schemeClr val="tx1"/>
          </a:solidFill>
          <a:latin typeface="+mn-lt"/>
          <a:ea typeface="+mn-ea"/>
          <a:cs typeface="+mn-cs"/>
        </a:defRPr>
      </a:lvl2pPr>
      <a:lvl3pPr marL="947318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658" kern="1200">
          <a:solidFill>
            <a:schemeClr val="tx1"/>
          </a:solidFill>
          <a:latin typeface="+mn-lt"/>
          <a:ea typeface="+mn-ea"/>
          <a:cs typeface="+mn-cs"/>
        </a:defRPr>
      </a:lvl3pPr>
      <a:lvl4pPr marL="1326246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4pPr>
      <a:lvl5pPr marL="1705173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5pPr>
      <a:lvl6pPr marL="2084100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6pPr>
      <a:lvl7pPr marL="2463028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7pPr>
      <a:lvl8pPr marL="2841955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8pPr>
      <a:lvl9pPr marL="3220883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1pPr>
      <a:lvl2pPr marL="378927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2pPr>
      <a:lvl3pPr marL="757855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3pPr>
      <a:lvl4pPr marL="1136782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4pPr>
      <a:lvl5pPr marL="1515709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5pPr>
      <a:lvl6pPr marL="1894637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6pPr>
      <a:lvl7pPr marL="2273564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7pPr>
      <a:lvl8pPr marL="2652492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8pPr>
      <a:lvl9pPr marL="3031419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6" name="组合 95"/>
          <p:cNvGrpSpPr/>
          <p:nvPr/>
        </p:nvGrpSpPr>
        <p:grpSpPr>
          <a:xfrm>
            <a:off x="493712" y="496031"/>
            <a:ext cx="6517622" cy="5447943"/>
            <a:chOff x="0" y="496028"/>
            <a:chExt cx="6517622" cy="5447943"/>
          </a:xfrm>
        </p:grpSpPr>
        <p:cxnSp>
          <p:nvCxnSpPr>
            <p:cNvPr id="74" name="直接连接符 73"/>
            <p:cNvCxnSpPr/>
            <p:nvPr/>
          </p:nvCxnSpPr>
          <p:spPr>
            <a:xfrm>
              <a:off x="2406408" y="1040598"/>
              <a:ext cx="0" cy="2731302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" name="直接连接符 90"/>
            <p:cNvCxnSpPr>
              <a:stCxn id="22" idx="2"/>
            </p:cNvCxnSpPr>
            <p:nvPr/>
          </p:nvCxnSpPr>
          <p:spPr>
            <a:xfrm flipH="1">
              <a:off x="5312709" y="1040598"/>
              <a:ext cx="1" cy="476752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接连接符 81"/>
            <p:cNvCxnSpPr/>
            <p:nvPr/>
          </p:nvCxnSpPr>
          <p:spPr>
            <a:xfrm>
              <a:off x="1536699" y="5396230"/>
              <a:ext cx="0" cy="4281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接连接符 79"/>
            <p:cNvCxnSpPr>
              <a:stCxn id="10" idx="2"/>
              <a:endCxn id="23" idx="0"/>
            </p:cNvCxnSpPr>
            <p:nvPr/>
          </p:nvCxnSpPr>
          <p:spPr>
            <a:xfrm>
              <a:off x="1536699" y="4583430"/>
              <a:ext cx="1" cy="2884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接连接符 56"/>
            <p:cNvCxnSpPr/>
            <p:nvPr/>
          </p:nvCxnSpPr>
          <p:spPr>
            <a:xfrm>
              <a:off x="1968501" y="1974249"/>
              <a:ext cx="438149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矩形 9"/>
            <p:cNvSpPr/>
            <p:nvPr/>
          </p:nvSpPr>
          <p:spPr>
            <a:xfrm>
              <a:off x="755649" y="4189730"/>
              <a:ext cx="1562100" cy="393700"/>
            </a:xfrm>
            <a:prstGeom prst="rect">
              <a:avLst/>
            </a:prstGeom>
            <a:solidFill>
              <a:srgbClr val="D1DFF3"/>
            </a:solidFill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zh-CN" altLang="en-US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raining cohort </a:t>
              </a:r>
            </a:p>
            <a:p>
              <a:pPr algn="ctr"/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</a:t>
              </a:r>
              <a:r>
                <a:rPr lang="zh-CN" altLang="en-US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=302</a:t>
              </a:r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sz="109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>
              <a:off x="2518481" y="4189730"/>
              <a:ext cx="1676400" cy="393700"/>
            </a:xfrm>
            <a:prstGeom prst="rect">
              <a:avLst/>
            </a:prstGeom>
            <a:solidFill>
              <a:srgbClr val="D1DFF3"/>
            </a:solidFill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nal validation cohort </a:t>
              </a:r>
            </a:p>
            <a:p>
              <a:pPr algn="ctr"/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=151)</a:t>
              </a:r>
              <a:endParaRPr lang="zh-CN" altLang="en-US" sz="109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>
              <a:off x="4421415" y="4189730"/>
              <a:ext cx="1676400" cy="393700"/>
            </a:xfrm>
            <a:prstGeom prst="rect">
              <a:avLst/>
            </a:prstGeom>
            <a:solidFill>
              <a:srgbClr val="D1DFF3"/>
            </a:solidFill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ternal validation cohort </a:t>
              </a:r>
            </a:p>
            <a:p>
              <a:pPr algn="ctr"/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=203)</a:t>
              </a:r>
              <a:endParaRPr lang="zh-CN" altLang="en-US" sz="109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>
              <a:off x="0" y="1370806"/>
              <a:ext cx="2032001" cy="1206886"/>
            </a:xfrm>
            <a:prstGeom prst="rect">
              <a:avLst/>
            </a:prstGeom>
            <a:solidFill>
              <a:srgbClr val="D1DFF3"/>
            </a:solidFill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ded                          (n=157)</a:t>
              </a:r>
            </a:p>
            <a:p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PC recurrence                   (n=8)</a:t>
              </a:r>
            </a:p>
            <a:p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PC metastasis                    (n=3)</a:t>
              </a:r>
            </a:p>
            <a:p>
              <a:r>
                <a:rPr lang="en-US" altLang="zh-CN" sz="1099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ost-radiotherapy stroke      (</a:t>
              </a:r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=5)</a:t>
              </a:r>
            </a:p>
            <a:p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issed baseline data          (n=31)</a:t>
              </a:r>
            </a:p>
            <a:p>
              <a:r>
                <a:rPr lang="en-US" altLang="zh-CN" sz="1099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ost to follow-up             </a:t>
              </a:r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=110)</a:t>
              </a:r>
            </a:p>
          </p:txBody>
        </p:sp>
        <p:sp>
          <p:nvSpPr>
            <p:cNvPr id="19" name="矩形 18"/>
            <p:cNvSpPr/>
            <p:nvPr/>
          </p:nvSpPr>
          <p:spPr>
            <a:xfrm>
              <a:off x="1287286" y="496028"/>
              <a:ext cx="2238243" cy="544570"/>
            </a:xfrm>
            <a:prstGeom prst="rect">
              <a:avLst/>
            </a:prstGeom>
            <a:solidFill>
              <a:srgbClr val="D1DFF3"/>
            </a:solidFill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LCNP after radiotherapy for NPC at SYSMH</a:t>
              </a:r>
            </a:p>
            <a:p>
              <a:pPr algn="ctr"/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= 610 )</a:t>
              </a:r>
              <a:endParaRPr lang="zh-CN" altLang="en-US" sz="109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>
              <a:off x="4107797" y="496028"/>
              <a:ext cx="2409825" cy="544570"/>
            </a:xfrm>
            <a:prstGeom prst="rect">
              <a:avLst/>
            </a:prstGeom>
            <a:solidFill>
              <a:srgbClr val="D1DFF3"/>
            </a:solidFill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LCNP after </a:t>
              </a:r>
            </a:p>
            <a:p>
              <a:pPr algn="ctr"/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adiotherapy for NPC at FPHF</a:t>
              </a:r>
            </a:p>
            <a:p>
              <a:pPr algn="ctr"/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= 270  )</a:t>
              </a:r>
              <a:endParaRPr lang="zh-CN" altLang="en-US" sz="109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739847" y="4871900"/>
              <a:ext cx="1593705" cy="430631"/>
            </a:xfrm>
            <a:prstGeom prst="rect">
              <a:avLst/>
            </a:prstGeom>
            <a:solidFill>
              <a:srgbClr val="D1DFF3"/>
            </a:solidFill>
            <a:ln w="19050">
              <a:solidFill>
                <a:srgbClr val="D1DFF3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uilding the Nomogram </a:t>
              </a:r>
            </a:p>
            <a:p>
              <a:pPr algn="ctr"/>
              <a:r>
                <a:rPr lang="en-US" altLang="zh-CN" sz="10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sing Cox Model</a:t>
              </a:r>
              <a:endParaRPr lang="zh-CN" altLang="en-US" sz="109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>
              <a:off x="988660" y="5617618"/>
              <a:ext cx="4736041" cy="326353"/>
            </a:xfrm>
            <a:prstGeom prst="rect">
              <a:avLst/>
            </a:prstGeom>
            <a:solidFill>
              <a:srgbClr val="D1DFF3"/>
            </a:solidFill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valuating the performance of Nomogram</a:t>
              </a:r>
              <a:endParaRPr lang="zh-CN" alt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椭圆 29"/>
            <p:cNvSpPr/>
            <p:nvPr/>
          </p:nvSpPr>
          <p:spPr>
            <a:xfrm>
              <a:off x="1475845" y="2775379"/>
              <a:ext cx="1861124" cy="608331"/>
            </a:xfrm>
            <a:prstGeom prst="ellipse">
              <a:avLst/>
            </a:prstGeom>
            <a:solidFill>
              <a:srgbClr val="D1DFF3"/>
            </a:solidFill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andom 2:1 ratio</a:t>
              </a:r>
            </a:p>
            <a:p>
              <a:pPr algn="ctr"/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=453)</a:t>
              </a:r>
              <a:endParaRPr lang="zh-CN" altLang="en-US" sz="109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矩形 33"/>
            <p:cNvSpPr/>
            <p:nvPr/>
          </p:nvSpPr>
          <p:spPr>
            <a:xfrm>
              <a:off x="4239288" y="1370806"/>
              <a:ext cx="2146841" cy="1206886"/>
            </a:xfrm>
            <a:prstGeom prst="rect">
              <a:avLst/>
            </a:prstGeom>
            <a:solidFill>
              <a:srgbClr val="D1DFF3"/>
            </a:solidFill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ded                         </a:t>
              </a:r>
              <a:r>
                <a:rPr lang="en-US" altLang="zh-CN" sz="1099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</a:t>
              </a:r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=67)</a:t>
              </a:r>
            </a:p>
            <a:p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PC recurrence               </a:t>
              </a:r>
              <a:r>
                <a:rPr lang="en-US" altLang="zh-CN" sz="1099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</a:t>
              </a:r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=3)</a:t>
              </a:r>
            </a:p>
            <a:p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issed baseline data    </a:t>
              </a:r>
              <a:r>
                <a:rPr lang="en-US" altLang="zh-CN" sz="1099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</a:t>
              </a:r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=18)</a:t>
              </a:r>
            </a:p>
            <a:p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ost to </a:t>
              </a:r>
              <a:r>
                <a:rPr lang="en-US" altLang="zh-CN" sz="1099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ollow-up                  </a:t>
              </a:r>
              <a:r>
                <a:rPr lang="en-US" altLang="zh-CN" sz="1099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n=46)</a:t>
              </a:r>
            </a:p>
          </p:txBody>
        </p:sp>
        <p:cxnSp>
          <p:nvCxnSpPr>
            <p:cNvPr id="38" name="肘形连接符 37"/>
            <p:cNvCxnSpPr>
              <a:stCxn id="10" idx="0"/>
              <a:endCxn id="11" idx="0"/>
            </p:cNvCxnSpPr>
            <p:nvPr/>
          </p:nvCxnSpPr>
          <p:spPr>
            <a:xfrm rot="5400000" flipH="1" flipV="1">
              <a:off x="2446690" y="3279739"/>
              <a:ext cx="12700" cy="1819982"/>
            </a:xfrm>
            <a:prstGeom prst="bentConnector3">
              <a:avLst>
                <a:gd name="adj1" fmla="val 3400000"/>
              </a:avLst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直接连接符 84"/>
            <p:cNvCxnSpPr>
              <a:stCxn id="11" idx="2"/>
              <a:endCxn id="25" idx="0"/>
            </p:cNvCxnSpPr>
            <p:nvPr/>
          </p:nvCxnSpPr>
          <p:spPr>
            <a:xfrm>
              <a:off x="3356681" y="4583430"/>
              <a:ext cx="0" cy="10341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81428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4</TotalTime>
  <Words>151</Words>
  <Application>Microsoft Office PowerPoint</Application>
  <PresentationFormat>自定义</PresentationFormat>
  <Paragraphs>29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卓 小煌</dc:creator>
  <cp:lastModifiedBy>hp</cp:lastModifiedBy>
  <cp:revision>53</cp:revision>
  <cp:lastPrinted>2019-09-14T19:04:36Z</cp:lastPrinted>
  <dcterms:created xsi:type="dcterms:W3CDTF">2019-09-12T16:54:40Z</dcterms:created>
  <dcterms:modified xsi:type="dcterms:W3CDTF">2022-07-10T08:09:42Z</dcterms:modified>
</cp:coreProperties>
</file>